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9272B5-B62A-4FD9-826D-02CC03047CD3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B4C508-5007-48F7-A27F-4673243CDC8A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87C904-B961-4C81-9529-86A84F3229E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F098BB-0C7D-4C20-9951-F10CFB8802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376C64-F9C4-4392-823C-071CDA58161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DEB847-7B2C-45CD-BC55-525022C5E42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B0D527-2BA4-4F78-BA7F-AA9044A058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68B0DA-297E-4689-BDFF-2A8B2D20C4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551469-F2B3-4CEA-A96B-F54D2A4E2C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F0134F-A342-41A8-B60A-8EF00EEBFA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82E35C-4299-4AC8-A18E-C84091912C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B33FDA-53FF-4807-BA60-C2C614E3EE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7E5EAE-AB22-4A79-AB89-2C6FEC7699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D3522F-3853-418A-9DDC-8CF0001D9D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C4F9433-42AC-4D99-B7B0-F568D2513B42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189000" y="728640"/>
          <a:ext cx="6335640" cy="5025960"/>
        </p:xfrm>
        <a:graphic>
          <a:graphicData uri="http://schemas.openxmlformats.org/drawingml/2006/table">
            <a:tbl>
              <a:tblPr/>
              <a:tblGrid>
                <a:gridCol w="704880"/>
                <a:gridCol w="666720"/>
                <a:gridCol w="644400"/>
                <a:gridCol w="692280"/>
                <a:gridCol w="650880"/>
                <a:gridCol w="706320"/>
                <a:gridCol w="704880"/>
                <a:gridCol w="708120"/>
                <a:gridCol w="857160"/>
              </a:tblGrid>
              <a:tr h="238680">
                <a:tc rowSpan="3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ome orig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4"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hoo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4"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oo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23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+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47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que </a:t>
                      </a:r>
                      <a:r>
                        <a:rPr b="1" lang="en-US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que </a:t>
                      </a:r>
                      <a:r>
                        <a:rPr b="1" lang="en-US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que </a:t>
                      </a:r>
                      <a:r>
                        <a:rPr b="1" lang="en-US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ique </a:t>
                      </a:r>
                      <a:r>
                        <a:rPr b="1" lang="en-US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4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xon antisen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1,8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88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,9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2.05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9,1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59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,7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2.19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5,2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87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,0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69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3,6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26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,3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80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82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x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nse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22,1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1.23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1,8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8.19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83,5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5.57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5,6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5.62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9,4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16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4,0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.65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3,045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87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,2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.94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4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r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tisen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,1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44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,2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2.88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,7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52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,4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.02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9,0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57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,9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2.36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6,2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17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,5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2.91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37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ntr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n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0,3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47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7,7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7.72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5,1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82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7,1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8.27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8,3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84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1,5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6.17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5,7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.48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8,5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6.88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2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iR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,291,3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27.90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1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13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,194,5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46.43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04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13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,464,3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28.65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1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8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,777,9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3.86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0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5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4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R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834,9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22.34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16,3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3.26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03,1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1.67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,44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9.79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,089,1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24.29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7,9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8.62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876,5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22.87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4,0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6.16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4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iR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5,8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56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,1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61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3,2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92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,94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2.09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,0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56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,4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38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3,2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5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2,8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2.13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26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nR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0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1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8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1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7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6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2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1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7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,9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4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5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7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37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noR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1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4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1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3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1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1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4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,3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3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0.04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4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R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50,5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4.27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,0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94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6,6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5.33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,0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98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05,5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4.72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,1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90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,807,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.42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,1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1.15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05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nann</a:t>
                      </a:r>
                      <a:r>
                        <a:rPr b="1" lang="en-US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,537,2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0.90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44,7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62.10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798,3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26.14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42,0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66.81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,208,99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7.31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098,2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74.04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,502,8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0.50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,508,0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74.88%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矩形 2"/>
          <p:cNvSpPr/>
          <p:nvPr/>
        </p:nvSpPr>
        <p:spPr>
          <a:xfrm>
            <a:off x="4556160" y="179280"/>
            <a:ext cx="2239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tabl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矩形 2"/>
          <p:cNvSpPr/>
          <p:nvPr/>
        </p:nvSpPr>
        <p:spPr>
          <a:xfrm>
            <a:off x="116640" y="6334200"/>
            <a:ext cx="4254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umbers in brackets indicate the percentage of the unique signatures or total signatures.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矩形 2"/>
          <p:cNvSpPr/>
          <p:nvPr/>
        </p:nvSpPr>
        <p:spPr>
          <a:xfrm>
            <a:off x="118440" y="6084720"/>
            <a:ext cx="1856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clude novel miRNA candidates.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矩形 2"/>
          <p:cNvSpPr/>
          <p:nvPr/>
        </p:nvSpPr>
        <p:spPr>
          <a:xfrm>
            <a:off x="106200" y="5778360"/>
            <a:ext cx="6461280" cy="53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 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“Unique” is the number that perfectly matching to at least one location in the genome and signature matching tRNAs, rRNAs, sRNAs,     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r snoRNA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02T07:36:24Z</dcterms:created>
  <dc:creator>MC SYSTEM</dc:creator>
  <dc:description/>
  <dc:language>en-US</dc:language>
  <cp:lastModifiedBy>MC SYSTEM</cp:lastModifiedBy>
  <dcterms:modified xsi:type="dcterms:W3CDTF">2011-05-17T02:26:54Z</dcterms:modified>
  <cp:revision>55</cp:revision>
  <dc:subject/>
  <dc:title>幻灯片 1</dc:title>
</cp:coreProperties>
</file>